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48" autoAdjust="0"/>
    <p:restoredTop sz="94857" autoAdjust="0"/>
  </p:normalViewPr>
  <p:slideViewPr>
    <p:cSldViewPr snapToGrid="0">
      <p:cViewPr varScale="1">
        <p:scale>
          <a:sx n="58" d="100"/>
          <a:sy n="58" d="100"/>
        </p:scale>
        <p:origin x="-2928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2D9A35-D9AC-4ACA-8D07-CE878B65E40E}" type="datetimeFigureOut">
              <a:rPr lang="en-GB" smtClean="0"/>
              <a:t>06/10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B2F34-813D-4426-B365-18AD8B1D2F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65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06.10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850533" y="7498125"/>
            <a:ext cx="2543632" cy="1844220"/>
            <a:chOff x="3463133" y="7498125"/>
            <a:chExt cx="2543632" cy="1844220"/>
          </a:xfrm>
        </p:grpSpPr>
        <p:pic>
          <p:nvPicPr>
            <p:cNvPr id="60" name="Picture 5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48412" y="7574476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1" name="TextBox 60"/>
            <p:cNvSpPr txBox="1"/>
            <p:nvPr/>
          </p:nvSpPr>
          <p:spPr>
            <a:xfrm>
              <a:off x="4212443" y="7650434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hreonat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193"/>
            <p:cNvSpPr txBox="1">
              <a:spLocks noChangeArrowheads="1"/>
            </p:cNvSpPr>
            <p:nvPr/>
          </p:nvSpPr>
          <p:spPr bwMode="auto">
            <a:xfrm>
              <a:off x="4543633" y="9065346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193"/>
            <p:cNvSpPr txBox="1">
              <a:spLocks noChangeArrowheads="1"/>
            </p:cNvSpPr>
            <p:nvPr/>
          </p:nvSpPr>
          <p:spPr bwMode="auto">
            <a:xfrm rot="16200000">
              <a:off x="2848221" y="8113037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8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8412" y="4103190"/>
            <a:ext cx="2058353" cy="1538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TextBox 193"/>
          <p:cNvSpPr txBox="1">
            <a:spLocks noChangeArrowheads="1"/>
          </p:cNvSpPr>
          <p:nvPr/>
        </p:nvSpPr>
        <p:spPr bwMode="auto">
          <a:xfrm rot="16200000">
            <a:off x="236324" y="4641751"/>
            <a:ext cx="169148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de-DE" alt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esponse</a:t>
            </a:r>
          </a:p>
          <a:p>
            <a:pPr algn="ctr"/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[mg</a:t>
            </a:r>
            <a:r>
              <a:rPr lang="de-DE" alt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M]</a:t>
            </a:r>
            <a:endParaRPr lang="de-DE" alt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09191" y="4175240"/>
            <a:ext cx="1568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xacosanoic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0516" y="4103190"/>
            <a:ext cx="2058353" cy="1538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Rectangle 21"/>
          <p:cNvSpPr/>
          <p:nvPr/>
        </p:nvSpPr>
        <p:spPr>
          <a:xfrm>
            <a:off x="1545733" y="4180607"/>
            <a:ext cx="180688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ctadecatrienoic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,12,15-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Z,Z,Z)-</a:t>
            </a:r>
          </a:p>
        </p:txBody>
      </p:sp>
      <p:sp>
        <p:nvSpPr>
          <p:cNvPr id="23" name="TextBox 193"/>
          <p:cNvSpPr txBox="1">
            <a:spLocks noChangeArrowheads="1"/>
          </p:cNvSpPr>
          <p:nvPr/>
        </p:nvSpPr>
        <p:spPr bwMode="auto">
          <a:xfrm>
            <a:off x="1925737" y="5599258"/>
            <a:ext cx="107112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de-DE" alt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osition</a:t>
            </a:r>
            <a:endParaRPr lang="de-DE" alt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93"/>
          <p:cNvSpPr txBox="1">
            <a:spLocks noChangeArrowheads="1"/>
          </p:cNvSpPr>
          <p:nvPr/>
        </p:nvSpPr>
        <p:spPr bwMode="auto">
          <a:xfrm>
            <a:off x="4543633" y="5599258"/>
            <a:ext cx="107112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de-DE" alt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osition</a:t>
            </a:r>
            <a:endParaRPr lang="de-DE" alt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193"/>
          <p:cNvSpPr txBox="1">
            <a:spLocks noChangeArrowheads="1"/>
          </p:cNvSpPr>
          <p:nvPr/>
        </p:nvSpPr>
        <p:spPr bwMode="auto">
          <a:xfrm rot="16200000">
            <a:off x="2848221" y="4641751"/>
            <a:ext cx="169148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de-DE" alt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esponse</a:t>
            </a:r>
          </a:p>
          <a:p>
            <a:pPr algn="ctr"/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[mg</a:t>
            </a:r>
            <a:r>
              <a:rPr lang="de-DE" alt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de-DE" alt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M]</a:t>
            </a:r>
            <a:endParaRPr lang="de-DE" alt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851236" y="2296852"/>
            <a:ext cx="5155529" cy="1843435"/>
            <a:chOff x="766867" y="1808250"/>
            <a:chExt cx="5155529" cy="1843435"/>
          </a:xfrm>
        </p:grpSpPr>
        <p:pic>
          <p:nvPicPr>
            <p:cNvPr id="27" name="Picture 9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46147" y="1884602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TextBox 30"/>
            <p:cNvSpPr txBox="1"/>
            <p:nvPr/>
          </p:nvSpPr>
          <p:spPr>
            <a:xfrm>
              <a:off x="1513494" y="1956652"/>
              <a:ext cx="10390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ycerol-3P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" name="Picture 10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4043" y="1884602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6" name="TextBox 35"/>
            <p:cNvSpPr txBox="1"/>
            <p:nvPr/>
          </p:nvSpPr>
          <p:spPr>
            <a:xfrm>
              <a:off x="4123811" y="1958111"/>
              <a:ext cx="14606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ycerophospho</a:t>
              </a:r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ycero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193"/>
            <p:cNvSpPr txBox="1">
              <a:spLocks noChangeArrowheads="1"/>
            </p:cNvSpPr>
            <p:nvPr/>
          </p:nvSpPr>
          <p:spPr bwMode="auto">
            <a:xfrm rot="16200000">
              <a:off x="151955" y="2423163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193"/>
            <p:cNvSpPr txBox="1">
              <a:spLocks noChangeArrowheads="1"/>
            </p:cNvSpPr>
            <p:nvPr/>
          </p:nvSpPr>
          <p:spPr bwMode="auto">
            <a:xfrm>
              <a:off x="1837460" y="3374686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193"/>
            <p:cNvSpPr txBox="1">
              <a:spLocks noChangeArrowheads="1"/>
            </p:cNvSpPr>
            <p:nvPr/>
          </p:nvSpPr>
          <p:spPr bwMode="auto">
            <a:xfrm>
              <a:off x="4455356" y="3374686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193"/>
            <p:cNvSpPr txBox="1">
              <a:spLocks noChangeArrowheads="1"/>
            </p:cNvSpPr>
            <p:nvPr/>
          </p:nvSpPr>
          <p:spPr bwMode="auto">
            <a:xfrm rot="16200000">
              <a:off x="2763852" y="2423162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851236" y="5762809"/>
            <a:ext cx="5155529" cy="1848763"/>
            <a:chOff x="766867" y="5384253"/>
            <a:chExt cx="5155529" cy="1848763"/>
          </a:xfrm>
        </p:grpSpPr>
        <p:pic>
          <p:nvPicPr>
            <p:cNvPr id="40" name="Picture 7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46147" y="5460604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TextBox 40"/>
            <p:cNvSpPr txBox="1"/>
            <p:nvPr/>
          </p:nvSpPr>
          <p:spPr>
            <a:xfrm>
              <a:off x="1513080" y="5532654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lycerat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Picture 1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4043" y="5460604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4" name="TextBox 43"/>
            <p:cNvSpPr txBox="1"/>
            <p:nvPr/>
          </p:nvSpPr>
          <p:spPr>
            <a:xfrm>
              <a:off x="4122867" y="5532654"/>
              <a:ext cx="9701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utrescin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193"/>
            <p:cNvSpPr txBox="1">
              <a:spLocks noChangeArrowheads="1"/>
            </p:cNvSpPr>
            <p:nvPr/>
          </p:nvSpPr>
          <p:spPr bwMode="auto">
            <a:xfrm rot="16200000">
              <a:off x="151955" y="5999165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193"/>
            <p:cNvSpPr txBox="1">
              <a:spLocks noChangeArrowheads="1"/>
            </p:cNvSpPr>
            <p:nvPr/>
          </p:nvSpPr>
          <p:spPr bwMode="auto">
            <a:xfrm>
              <a:off x="1841368" y="6956017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193"/>
            <p:cNvSpPr txBox="1">
              <a:spLocks noChangeArrowheads="1"/>
            </p:cNvSpPr>
            <p:nvPr/>
          </p:nvSpPr>
          <p:spPr bwMode="auto">
            <a:xfrm>
              <a:off x="4459264" y="6956017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193"/>
            <p:cNvSpPr txBox="1">
              <a:spLocks noChangeArrowheads="1"/>
            </p:cNvSpPr>
            <p:nvPr/>
          </p:nvSpPr>
          <p:spPr bwMode="auto">
            <a:xfrm rot="16200000">
              <a:off x="2763852" y="5999165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851236" y="561635"/>
            <a:ext cx="5155529" cy="1848665"/>
            <a:chOff x="766867" y="21255"/>
            <a:chExt cx="5155529" cy="1848665"/>
          </a:xfrm>
        </p:grpSpPr>
        <p:pic>
          <p:nvPicPr>
            <p:cNvPr id="50" name="Picture 7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4043" y="97606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1" name="TextBox 50"/>
            <p:cNvSpPr txBox="1"/>
            <p:nvPr/>
          </p:nvSpPr>
          <p:spPr>
            <a:xfrm>
              <a:off x="4127487" y="173564"/>
              <a:ext cx="1101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yo</a:t>
              </a:r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-Inosito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2" name="Picture 5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46147" y="97606"/>
              <a:ext cx="2058353" cy="15387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3" name="TextBox 52"/>
            <p:cNvSpPr txBox="1"/>
            <p:nvPr/>
          </p:nvSpPr>
          <p:spPr>
            <a:xfrm>
              <a:off x="1508763" y="173564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ucros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193"/>
            <p:cNvSpPr txBox="1">
              <a:spLocks noChangeArrowheads="1"/>
            </p:cNvSpPr>
            <p:nvPr/>
          </p:nvSpPr>
          <p:spPr bwMode="auto">
            <a:xfrm rot="16200000">
              <a:off x="151955" y="636167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193"/>
            <p:cNvSpPr txBox="1">
              <a:spLocks noChangeArrowheads="1"/>
            </p:cNvSpPr>
            <p:nvPr/>
          </p:nvSpPr>
          <p:spPr bwMode="auto">
            <a:xfrm>
              <a:off x="1837460" y="1592921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193"/>
            <p:cNvSpPr txBox="1">
              <a:spLocks noChangeArrowheads="1"/>
            </p:cNvSpPr>
            <p:nvPr/>
          </p:nvSpPr>
          <p:spPr bwMode="auto">
            <a:xfrm>
              <a:off x="4455356" y="1592921"/>
              <a:ext cx="107112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af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Position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193"/>
            <p:cNvSpPr txBox="1">
              <a:spLocks noChangeArrowheads="1"/>
            </p:cNvSpPr>
            <p:nvPr/>
          </p:nvSpPr>
          <p:spPr bwMode="auto">
            <a:xfrm rot="16200000">
              <a:off x="2763851" y="636167"/>
              <a:ext cx="169148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algn="ctr"/>
              <a:r>
                <a:rPr lang="de-DE" alt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sponse</a:t>
              </a:r>
            </a:p>
            <a:p>
              <a:pPr algn="ctr"/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mg</a:t>
              </a:r>
              <a:r>
                <a:rPr lang="de-DE" altLang="de-DE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de-DE" alt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DM]</a:t>
              </a:r>
              <a:endParaRPr lang="de-DE" alt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0" y="0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: Figure S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5665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A4 Paper (210x297 mm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erik Dethloff</dc:creator>
  <cp:lastModifiedBy>Joachim Kopka</cp:lastModifiedBy>
  <cp:revision>229</cp:revision>
  <dcterms:created xsi:type="dcterms:W3CDTF">2013-11-13T09:19:03Z</dcterms:created>
  <dcterms:modified xsi:type="dcterms:W3CDTF">2017-10-06T09:08:41Z</dcterms:modified>
</cp:coreProperties>
</file>